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7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60BF0-EFB8-4653-A420-1E88DED94314}" type="datetimeFigureOut">
              <a:rPr lang="it-IT" smtClean="0"/>
              <a:pPr/>
              <a:t>10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8942A-89DB-4AED-AD73-7D1E776E46D7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/>
        </p:nvGraphicFramePr>
        <p:xfrm>
          <a:off x="1475656" y="620688"/>
          <a:ext cx="5163259" cy="5976744"/>
        </p:xfrm>
        <a:graphic>
          <a:graphicData uri="http://schemas.openxmlformats.org/drawingml/2006/table">
            <a:tbl>
              <a:tblPr/>
              <a:tblGrid>
                <a:gridCol w="1035872"/>
                <a:gridCol w="864121"/>
                <a:gridCol w="794348"/>
                <a:gridCol w="1410115"/>
                <a:gridCol w="1058803"/>
              </a:tblGrid>
              <a:tr h="49034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b="1" kern="0" dirty="0" err="1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Hugo_Symbol</a:t>
                      </a:r>
                      <a:endParaRPr lang="it-IT" sz="900" kern="100" dirty="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b="1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HGVSc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b="1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HGVSp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b="1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umor_Sample_Barcode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b="1" kern="0" dirty="0" err="1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ubtype</a:t>
                      </a:r>
                      <a:endParaRPr lang="it-IT" sz="900" kern="100" dirty="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800C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n934T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1-A0SH-01A-11D-A099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 dirty="0" smtClea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 dirty="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5G&gt;C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u9Gln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1-A0SI-01A-11D-A142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oth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80+1G&gt;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1-A0SO-01A-22D-A099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158G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u720T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2-A25B-01A-11D-A167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oth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061_2064delGAC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Thr688ValfsTer12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7-A26H-01A-11D-A167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709del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Cys903TrpfsTer97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7-A6VW-01A-21D-A33E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3292C&gt;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Leu1098Ile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N-A046-01A-21W-A050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5363G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y1788V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N-A0XU-01A-11D-A10G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1931_1933delGT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Cys644de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AO-A1KR-01A-12D-A142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67delG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u23SerfsTer8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B6-A0X1-01A-11D-A10G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5432A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n1811Leu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BH-A0DS-01A-11W-A071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4030G&gt;C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Asp1344His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C8-A12T-01A-11D-A10Y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oth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4841delC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Pro1614GlnfsTer1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D8-A27M-01A-11D-A16D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6T&gt;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Asp2Glu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E2-A1BD-01A-11D-A12Q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3080G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Ser1027Ile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E2-A1L9-01A-11D-A13L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415C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n139T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E9-A1NC-01A-12W-A16L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744C&gt;G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Ser915Cys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GM-A2D9-01A-11D-A18P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286G&gt;C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Asp96His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LL-A5YP-01A-21D-A28B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4222C&gt;T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n1408Ter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LL-A8F5-01A-11D-A36J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al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06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RCA1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.4255G&gt;A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.Glu1419Lys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GA-PE-A5DE-01A-11D-A27P-09</a:t>
                      </a:r>
                      <a:endParaRPr lang="it-IT" sz="900" kern="10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900" kern="0" dirty="0" err="1">
                          <a:solidFill>
                            <a:srgbClr val="222222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uminalA</a:t>
                      </a:r>
                      <a:endParaRPr lang="it-IT" sz="900" kern="100" dirty="0">
                        <a:latin typeface="Times New Roman" pitchFamily="18" charset="0"/>
                        <a:ea typeface="Noto Serif CJK SC"/>
                        <a:cs typeface="Times New Roman" pitchFamily="18" charset="0"/>
                      </a:endParaRPr>
                    </a:p>
                  </a:txBody>
                  <a:tcPr marL="23204" marR="2320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0" y="44624"/>
            <a:ext cx="22668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it-IT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b="1" dirty="0" err="1" smtClean="0">
                <a:latin typeface="Times New Roman" pitchFamily="18" charset="0"/>
                <a:cs typeface="Times New Roman" pitchFamily="18" charset="0"/>
              </a:rPr>
              <a:t>Table</a:t>
            </a:r>
            <a:r>
              <a:rPr lang="it-IT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endParaRPr lang="it-IT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08</Words>
  <Application>Microsoft Office PowerPoint</Application>
  <PresentationFormat>Presentazione su schermo (4:3)</PresentationFormat>
  <Paragraphs>10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ser</dc:creator>
  <cp:lastModifiedBy>user</cp:lastModifiedBy>
  <cp:revision>7</cp:revision>
  <dcterms:created xsi:type="dcterms:W3CDTF">2021-02-25T13:39:32Z</dcterms:created>
  <dcterms:modified xsi:type="dcterms:W3CDTF">2021-05-10T13:36:12Z</dcterms:modified>
</cp:coreProperties>
</file>